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994508-195C-3572-2A29-FFF7DA59810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5B910AB-06BA-782E-0559-735F856ABD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5A5DDB-7508-72D7-7255-EF98506232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0A888-AE33-40F5-B2A7-11FEFA8834F9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6CB401-53C1-4CB7-D2BF-7B3646032A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48D7D5-0072-94B7-6753-F185392EA8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453A96-6BCD-48D8-80F6-B0A91220351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5678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5410AC-8058-9518-B846-E2C61CBA3D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D3F854-CECE-8989-28E5-E862D5D45A0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52D94C-0973-DFCB-ACC1-168D3509A7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0A888-AE33-40F5-B2A7-11FEFA8834F9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94EE31-0DB9-821A-784E-064D8E923C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4C00B7-A22F-CAF8-DB08-475E336BFA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453A96-6BCD-48D8-80F6-B0A91220351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6296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5320842-BE7C-C4B6-AD17-01CFBA80B95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FA1966C-15E4-3DFB-FF26-A98DA1291F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D54D4C-C36F-9EB8-F24B-D248E85546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0A888-AE33-40F5-B2A7-11FEFA8834F9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233900-E480-7F19-CFF4-457529FD86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5CC1EC-4C9A-DAB0-96D4-CB27553C92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453A96-6BCD-48D8-80F6-B0A91220351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5221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2080E5-8A03-BB85-D58B-4435EED8E9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7B930D1-21E3-A1B0-CA1C-6EC46D80A21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14470C-2E02-8802-D6CC-C551B531A7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0A888-AE33-40F5-B2A7-11FEFA8834F9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A7EA08-38DB-FE21-82A6-6BFC93393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5E4424-D5BB-277B-6D94-799ADB99CA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453A96-6BCD-48D8-80F6-B0A91220351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8932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931AEC-BA18-8904-127D-9DEAE46609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09080A7-E370-D224-D50D-9A76CEFEC3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654A89-83F1-140F-913A-5D39497282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0A888-AE33-40F5-B2A7-11FEFA8834F9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B99D86-DE7F-53FB-E27F-D7656BD4C0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FADE5EB-0251-44C0-CD08-314D32DC1E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453A96-6BCD-48D8-80F6-B0A91220351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1647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71E440-4966-C04C-7D68-332EB3CB48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5B7CD6-6680-5254-EF36-DAD908CE733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1EECDB3-A891-AFF0-8CB2-9176083DDD1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853A15-8997-5FBE-DA94-7A04DA9AA9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0A888-AE33-40F5-B2A7-11FEFA8834F9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AFD8A8-1B1C-345F-7D1D-3ACA7D5EDB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14BECC4-2C90-705B-0047-DDD549AAE1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453A96-6BCD-48D8-80F6-B0A91220351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89206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B3E74A-8AC7-0DF6-CC1C-26B3445FDD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532043-0C4E-1269-A5BF-001C4010AA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F46687D-53F6-D553-789E-E75688C230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15544C5-AE31-C19D-026F-DC5E088D099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FC390F4-FD0B-8EA0-2E7A-F457CDCCEA4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61D8250-E923-0D6D-FC9C-381656DE87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0A888-AE33-40F5-B2A7-11FEFA8834F9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E187C5C-7F6C-3C04-F433-74C6D7DA1C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716DA69-7136-0EC8-1260-F552045A3A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453A96-6BCD-48D8-80F6-B0A91220351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030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F99CDB-5634-85C0-3EEB-57FC9B0D72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DB7AA21-EA32-B2BD-AE2D-60C5A157E9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0A888-AE33-40F5-B2A7-11FEFA8834F9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F29A290-B266-F860-E7B5-182B64B0B2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BE72CFF-B110-3A75-A83E-75B8D3E6AD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453A96-6BCD-48D8-80F6-B0A91220351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4792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86354C2-7E45-0D37-B15C-97C22AA740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0A888-AE33-40F5-B2A7-11FEFA8834F9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DBC4DD6-ADD3-0FA4-AD2F-5DB117BC27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F9662CC-A32A-B9AA-8F1C-8C5ABEAA06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453A96-6BCD-48D8-80F6-B0A91220351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07965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B8386D-058A-391E-DB3A-876F392E88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663AD3-98F0-0277-FFCD-3974421BA54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B352999-1E85-3E65-0573-6865297FAC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947442-4A29-6B1F-7F43-C09455B983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0A888-AE33-40F5-B2A7-11FEFA8834F9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C322BC-4145-4A5A-FB0A-5C439D5FEC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2A8B41-3F68-8FD2-9E42-1B51E638D6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453A96-6BCD-48D8-80F6-B0A91220351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623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6FCB70-593C-5D39-4FD0-DF59BB65F4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DDDC458-7D63-6B82-FAFE-1BB90BBA493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9DABAF-648C-E05D-11D8-388DADC2D5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81E0F0-04DB-C9E5-6C8C-2B5B08CB3D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30A888-AE33-40F5-B2A7-11FEFA8834F9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808451-AA4E-67AE-114F-83E7C486F6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C7A1BD8-46E3-C3FF-AEB9-9D80D5F99F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453A96-6BCD-48D8-80F6-B0A91220351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4270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5DE8A9D-E24F-B8FF-848C-38FBF76A37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BC1818-E1E5-286F-59A8-244DB4EAF9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A70344-C526-0912-E98A-47B6FFFCE60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30A888-AE33-40F5-B2A7-11FEFA8834F9}" type="datetimeFigureOut">
              <a:rPr lang="en-US" smtClean="0"/>
              <a:t>10/9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620ABE-9F04-2A0C-B3FD-9021DEE52F3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8A40FA-36A4-3AA7-0914-6C6A73C35F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453A96-6BCD-48D8-80F6-B0A91220351F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0689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3.mp4"/><Relationship Id="rId1" Type="http://schemas.microsoft.com/office/2007/relationships/media" Target="../media/media3.mp4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385B225-2213-4B84-0813-98DD8895A8F1}"/>
              </a:ext>
            </a:extLst>
          </p:cNvPr>
          <p:cNvSpPr txBox="1"/>
          <p:nvPr/>
        </p:nvSpPr>
        <p:spPr>
          <a:xfrm>
            <a:off x="609600" y="321733"/>
            <a:ext cx="11142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ovie S1: Movement elicited by a vermal Purkinje cell stimulation at the midline (30 mW/mm², 400 ms stimulation).</a:t>
            </a:r>
          </a:p>
        </p:txBody>
      </p:sp>
      <p:pic>
        <p:nvPicPr>
          <p:cNvPr id="2" name="Movie_S1">
            <a:hlinkClick r:id="" action="ppaction://media"/>
            <a:extLst>
              <a:ext uri="{FF2B5EF4-FFF2-40B4-BE49-F238E27FC236}">
                <a16:creationId xmlns:a16="http://schemas.microsoft.com/office/drawing/2014/main" id="{8D80B4F1-846F-47CB-BCA2-A94B1FC28F25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175924" y="1175334"/>
            <a:ext cx="5268293" cy="50656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5011569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02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MovieS2">
            <a:hlinkClick r:id="" action="ppaction://media"/>
            <a:extLst>
              <a:ext uri="{FF2B5EF4-FFF2-40B4-BE49-F238E27FC236}">
                <a16:creationId xmlns:a16="http://schemas.microsoft.com/office/drawing/2014/main" id="{87A911C8-4596-8479-4210-85B1F827A7C0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810287" y="1211790"/>
            <a:ext cx="6571425" cy="5265209"/>
          </a:xfr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353FE8E-0832-22B7-19FA-8670CD7DF668}"/>
              </a:ext>
            </a:extLst>
          </p:cNvPr>
          <p:cNvSpPr txBox="1"/>
          <p:nvPr/>
        </p:nvSpPr>
        <p:spPr>
          <a:xfrm>
            <a:off x="609600" y="321733"/>
            <a:ext cx="1114213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ovie S2: Movements elicited by a vermal Purkinje cell stimulation at the midline across sensorimotor states (30 mW/mm², 400 ms stimulations)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E3C4FC9-009D-3E88-7B25-9C378AFBFA17}"/>
              </a:ext>
            </a:extLst>
          </p:cNvPr>
          <p:cNvSpPr txBox="1"/>
          <p:nvPr/>
        </p:nvSpPr>
        <p:spPr>
          <a:xfrm rot="16200000">
            <a:off x="1900445" y="5801266"/>
            <a:ext cx="982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Rearing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43A350C-A2C7-F12F-B1C1-A9CE6C001013}"/>
              </a:ext>
            </a:extLst>
          </p:cNvPr>
          <p:cNvSpPr txBox="1"/>
          <p:nvPr/>
        </p:nvSpPr>
        <p:spPr>
          <a:xfrm rot="16200000">
            <a:off x="1900446" y="2619231"/>
            <a:ext cx="982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At res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D393A53-3255-06C7-5C6B-6A7A34DA4506}"/>
              </a:ext>
            </a:extLst>
          </p:cNvPr>
          <p:cNvSpPr txBox="1"/>
          <p:nvPr/>
        </p:nvSpPr>
        <p:spPr>
          <a:xfrm rot="16200000">
            <a:off x="1900445" y="4734468"/>
            <a:ext cx="982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Walking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5127E772-8718-E1C4-F790-61E8D099576B}"/>
              </a:ext>
            </a:extLst>
          </p:cNvPr>
          <p:cNvCxnSpPr/>
          <p:nvPr/>
        </p:nvCxnSpPr>
        <p:spPr>
          <a:xfrm>
            <a:off x="2683933" y="1211790"/>
            <a:ext cx="0" cy="3140077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08A192FD-4805-B8A8-D1B1-E14A8D7F5EAD}"/>
              </a:ext>
            </a:extLst>
          </p:cNvPr>
          <p:cNvCxnSpPr>
            <a:cxnSpLocks/>
          </p:cNvCxnSpPr>
          <p:nvPr/>
        </p:nvCxnSpPr>
        <p:spPr>
          <a:xfrm>
            <a:off x="2683933" y="4394200"/>
            <a:ext cx="0" cy="1016001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14CDE2D5-7F3A-5788-0615-3B0D6F4A9115}"/>
              </a:ext>
            </a:extLst>
          </p:cNvPr>
          <p:cNvCxnSpPr>
            <a:cxnSpLocks/>
          </p:cNvCxnSpPr>
          <p:nvPr/>
        </p:nvCxnSpPr>
        <p:spPr>
          <a:xfrm>
            <a:off x="2679699" y="5435599"/>
            <a:ext cx="0" cy="1016001"/>
          </a:xfrm>
          <a:prstGeom prst="straightConnector1">
            <a:avLst/>
          </a:prstGeom>
          <a:ln>
            <a:headEnd type="triangle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7803742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26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AD85C446-B06E-41DC-BC7B-7D78F93498ED}"/>
              </a:ext>
            </a:extLst>
          </p:cNvPr>
          <p:cNvSpPr txBox="1"/>
          <p:nvPr/>
        </p:nvSpPr>
        <p:spPr>
          <a:xfrm>
            <a:off x="609600" y="321733"/>
            <a:ext cx="111421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ovie S3: The stimulation effect can be decomposed into four phases (30 mW/mm², 400 ms stimulations).</a:t>
            </a:r>
          </a:p>
        </p:txBody>
      </p:sp>
      <p:pic>
        <p:nvPicPr>
          <p:cNvPr id="9" name="Movie_S3">
            <a:hlinkClick r:id="" action="ppaction://media"/>
            <a:extLst>
              <a:ext uri="{FF2B5EF4-FFF2-40B4-BE49-F238E27FC236}">
                <a16:creationId xmlns:a16="http://schemas.microsoft.com/office/drawing/2014/main" id="{3993C31F-DEB8-471E-A66C-A407550AE6B9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3175923" y="1175334"/>
            <a:ext cx="5268293" cy="50656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717868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9200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video>
              <p:cMediaNode vol="80000">
                <p:cTn id="12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5</TotalTime>
  <Words>77</Words>
  <Application>Microsoft Office PowerPoint</Application>
  <PresentationFormat>Grand écran</PresentationFormat>
  <Paragraphs>6</Paragraphs>
  <Slides>3</Slides>
  <Notes>0</Notes>
  <HiddenSlides>0</HiddenSlides>
  <MMClips>3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rélien Gouhier</dc:creator>
  <cp:lastModifiedBy>Aurelien G</cp:lastModifiedBy>
  <cp:revision>7</cp:revision>
  <dcterms:created xsi:type="dcterms:W3CDTF">2023-05-11T13:32:09Z</dcterms:created>
  <dcterms:modified xsi:type="dcterms:W3CDTF">2023-10-09T11:48:08Z</dcterms:modified>
</cp:coreProperties>
</file>